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</p:sldIdLst>
  <p:sldSz cx="7772400" cy="10058400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-2016" y="-128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0454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12102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11104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472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54955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5579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42077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5767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484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946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8118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94983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1668161" y="1841156"/>
            <a:ext cx="5041353" cy="3892378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668161" y="5733534"/>
            <a:ext cx="537519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6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aplan-Meier curves 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omparing PFS in patients with different Child-Pugh grade.  Log-rank test demonstrated no significant association between PFS and Child-Pugh grade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32100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46</TotalTime>
  <Words>35</Words>
  <Application>Microsoft Macintosh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tg55</dc:creator>
  <cp:lastModifiedBy>Ryan T</cp:lastModifiedBy>
  <cp:revision>23</cp:revision>
  <cp:lastPrinted>2015-04-23T21:25:43Z</cp:lastPrinted>
  <dcterms:created xsi:type="dcterms:W3CDTF">2015-04-23T20:59:46Z</dcterms:created>
  <dcterms:modified xsi:type="dcterms:W3CDTF">2015-05-29T02:14:07Z</dcterms:modified>
</cp:coreProperties>
</file>